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  <p:sldId id="26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2925" autoAdjust="0"/>
  </p:normalViewPr>
  <p:slideViewPr>
    <p:cSldViewPr snapToGrid="0" snapToObjects="1">
      <p:cViewPr varScale="1">
        <p:scale>
          <a:sx n="114" d="100"/>
          <a:sy n="114" d="100"/>
        </p:scale>
        <p:origin x="9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gH2AX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H$2,Sheet1!$H$6,Sheet1!$H$10,Sheet1!$H$14)</c:f>
                <c:numCache>
                  <c:formatCode>General</c:formatCode>
                  <c:ptCount val="4"/>
                  <c:pt idx="0">
                    <c:v>2.8128693577611739E-3</c:v>
                  </c:pt>
                  <c:pt idx="1">
                    <c:v>5.6053794991229753E-3</c:v>
                  </c:pt>
                  <c:pt idx="2">
                    <c:v>2.5763576850640225E-3</c:v>
                  </c:pt>
                  <c:pt idx="3">
                    <c:v>2.47763949110423E-3</c:v>
                  </c:pt>
                </c:numCache>
              </c:numRef>
            </c:plus>
            <c:minus>
              <c:numRef>
                <c:f>(Sheet1!$H$2,Sheet1!$H$6,Sheet1!$H$10,Sheet1!$H$14)</c:f>
                <c:numCache>
                  <c:formatCode>General</c:formatCode>
                  <c:ptCount val="4"/>
                  <c:pt idx="0">
                    <c:v>2.8128693577611739E-3</c:v>
                  </c:pt>
                  <c:pt idx="1">
                    <c:v>5.6053794991229753E-3</c:v>
                  </c:pt>
                  <c:pt idx="2">
                    <c:v>2.5763576850640225E-3</c:v>
                  </c:pt>
                  <c:pt idx="3">
                    <c:v>2.4776394911042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A$2,Sheet1!$A$6,Sheet1!$A$10,Sheet1!$A$14)</c:f>
              <c:strCache>
                <c:ptCount val="4"/>
                <c:pt idx="0">
                  <c:v>DMSO</c:v>
                </c:pt>
                <c:pt idx="1">
                  <c:v>TRP 4hr</c:v>
                </c:pt>
                <c:pt idx="2">
                  <c:v>dBET6 4hr</c:v>
                </c:pt>
                <c:pt idx="3">
                  <c:v>Both 4hr</c:v>
                </c:pt>
              </c:strCache>
            </c:strRef>
          </c:cat>
          <c:val>
            <c:numRef>
              <c:f>(Sheet1!$G$2,Sheet1!$G$6,Sheet1!$G$10,Sheet1!$G$14)</c:f>
              <c:numCache>
                <c:formatCode>General</c:formatCode>
                <c:ptCount val="4"/>
                <c:pt idx="0">
                  <c:v>3.8310128344974305E-2</c:v>
                </c:pt>
                <c:pt idx="1">
                  <c:v>4.4020342848660715E-2</c:v>
                </c:pt>
                <c:pt idx="2">
                  <c:v>7.4060860694574446E-2</c:v>
                </c:pt>
                <c:pt idx="3">
                  <c:v>3.840199236606045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76-4943-B909-57A1D6DAAB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0403568"/>
        <c:axId val="420408488"/>
      </c:barChart>
      <c:catAx>
        <c:axId val="42040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0408488"/>
        <c:crosses val="autoZero"/>
        <c:auto val="1"/>
        <c:lblAlgn val="ctr"/>
        <c:lblOffset val="100"/>
        <c:noMultiLvlLbl val="0"/>
      </c:catAx>
      <c:valAx>
        <c:axId val="4204084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Signal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#,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04035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315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510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46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731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12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004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445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70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063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581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288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2E52E-FA61-1F4E-A2EF-2ABBD10CBD49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5B542-5A02-F243-82FF-8C7860C242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290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18" Type="http://schemas.openxmlformats.org/officeDocument/2006/relationships/image" Target="../media/image19.png"/><Relationship Id="rId3" Type="http://schemas.openxmlformats.org/officeDocument/2006/relationships/image" Target="../media/image4.png"/><Relationship Id="rId21" Type="http://schemas.openxmlformats.org/officeDocument/2006/relationships/image" Target="../media/image22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chart" Target="../charts/chart1.xml"/><Relationship Id="rId16" Type="http://schemas.openxmlformats.org/officeDocument/2006/relationships/image" Target="../media/image17.png"/><Relationship Id="rId20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19" Type="http://schemas.openxmlformats.org/officeDocument/2006/relationships/image" Target="../media/image20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Relationship Id="rId22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96067" y="-286888"/>
            <a:ext cx="11015830" cy="2387600"/>
          </a:xfrm>
        </p:spPr>
        <p:txBody>
          <a:bodyPr>
            <a:normAutofit/>
          </a:bodyPr>
          <a:lstStyle/>
          <a:p>
            <a:r>
              <a:rPr lang="en-US" sz="4800" dirty="0" err="1"/>
              <a:t>Triptolide</a:t>
            </a:r>
            <a:r>
              <a:rPr lang="en-US" sz="4800" dirty="0"/>
              <a:t>-Mediated Rescue of dBET6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75237" y="2666123"/>
            <a:ext cx="9144000" cy="1655762"/>
          </a:xfrm>
        </p:spPr>
        <p:txBody>
          <a:bodyPr/>
          <a:lstStyle/>
          <a:p>
            <a:r>
              <a:rPr lang="en-US" dirty="0"/>
              <a:t>11/20/2017</a:t>
            </a:r>
          </a:p>
          <a:p>
            <a:r>
              <a:rPr lang="en-US" dirty="0"/>
              <a:t>Triplicates</a:t>
            </a:r>
          </a:p>
        </p:txBody>
      </p:sp>
    </p:spTree>
    <p:extLst>
      <p:ext uri="{BB962C8B-B14F-4D97-AF65-F5344CB8AC3E}">
        <p14:creationId xmlns:p14="http://schemas.microsoft.com/office/powerpoint/2010/main" val="726191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4066" y="0"/>
            <a:ext cx="10515600" cy="1325563"/>
          </a:xfrm>
        </p:spPr>
        <p:txBody>
          <a:bodyPr/>
          <a:lstStyle/>
          <a:p>
            <a:r>
              <a:rPr lang="en-US"/>
              <a:t>Setup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4066" y="1235252"/>
            <a:ext cx="11161889" cy="4351338"/>
          </a:xfrm>
        </p:spPr>
        <p:txBody>
          <a:bodyPr/>
          <a:lstStyle/>
          <a:p>
            <a:r>
              <a:rPr lang="en-US" dirty="0"/>
              <a:t>Treat for 4hrs -&gt; Harvest </a:t>
            </a:r>
          </a:p>
          <a:p>
            <a:r>
              <a:rPr lang="en-US" dirty="0"/>
              <a:t>Western Blotting (Brd4, Total RNAP, Tubulin) + (gH2AX, Actin)</a:t>
            </a:r>
          </a:p>
          <a:p>
            <a:r>
              <a:rPr lang="en-US" dirty="0"/>
              <a:t>Conditions (In Triplicates):</a:t>
            </a:r>
          </a:p>
          <a:p>
            <a:pPr lvl="1"/>
            <a:r>
              <a:rPr lang="en-US" dirty="0"/>
              <a:t>DMSO</a:t>
            </a:r>
          </a:p>
          <a:p>
            <a:pPr lvl="1"/>
            <a:r>
              <a:rPr lang="en-US" dirty="0"/>
              <a:t>100nM dBET6</a:t>
            </a:r>
          </a:p>
          <a:p>
            <a:pPr lvl="1"/>
            <a:r>
              <a:rPr lang="en-US" dirty="0"/>
              <a:t>1uM </a:t>
            </a:r>
            <a:r>
              <a:rPr lang="en-US" dirty="0" err="1"/>
              <a:t>Trp</a:t>
            </a:r>
            <a:endParaRPr lang="en-US" dirty="0"/>
          </a:p>
          <a:p>
            <a:pPr lvl="1"/>
            <a:r>
              <a:rPr lang="en-US" dirty="0"/>
              <a:t>100nM dBET6 + 1uM </a:t>
            </a:r>
            <a:r>
              <a:rPr lang="en-US" dirty="0" err="1"/>
              <a:t>Tr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56191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14378" y="0"/>
            <a:ext cx="10515600" cy="1133652"/>
          </a:xfrm>
        </p:spPr>
        <p:txBody>
          <a:bodyPr/>
          <a:lstStyle/>
          <a:p>
            <a:r>
              <a:rPr lang="en-US" dirty="0"/>
              <a:t>Brd4</a:t>
            </a:r>
          </a:p>
        </p:txBody>
      </p:sp>
      <p:pic>
        <p:nvPicPr>
          <p:cNvPr id="4" name="Picture 3"/>
          <p:cNvPicPr/>
          <p:nvPr/>
        </p:nvPicPr>
        <p:blipFill rotWithShape="1">
          <a:blip r:embed="rId2"/>
          <a:srcRect l="4561" r="12089" b="7720"/>
          <a:stretch/>
        </p:blipFill>
        <p:spPr>
          <a:xfrm>
            <a:off x="270933" y="566826"/>
            <a:ext cx="10004776" cy="606707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1088508" y="1320800"/>
            <a:ext cx="15917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Brd4</a:t>
            </a:r>
          </a:p>
        </p:txBody>
      </p:sp>
      <p:cxnSp>
        <p:nvCxnSpPr>
          <p:cNvPr id="9" name="Straight Arrow Connector 8"/>
          <p:cNvCxnSpPr>
            <a:stCxn id="7" idx="1"/>
          </p:cNvCxnSpPr>
          <p:nvPr/>
        </p:nvCxnSpPr>
        <p:spPr>
          <a:xfrm flipH="1">
            <a:off x="9934222" y="1505466"/>
            <a:ext cx="11542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9144000" y="995152"/>
            <a:ext cx="71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8432800" y="998645"/>
            <a:ext cx="71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738531" y="1002138"/>
            <a:ext cx="711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27331" y="995151"/>
            <a:ext cx="677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5537198" y="1002137"/>
            <a:ext cx="677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6324597" y="1009051"/>
            <a:ext cx="6773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4775200" y="995151"/>
            <a:ext cx="838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BET6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392304" y="1009051"/>
            <a:ext cx="838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BET</a:t>
            </a:r>
            <a:r>
              <a:rPr lang="en-US" sz="1200" dirty="0"/>
              <a:t>6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064000" y="994268"/>
            <a:ext cx="838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BET</a:t>
            </a:r>
            <a:r>
              <a:rPr lang="en-US" sz="1200" dirty="0"/>
              <a:t>6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07733" y="1002137"/>
            <a:ext cx="911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oth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950145" y="998220"/>
            <a:ext cx="911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oth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13564" y="1002137"/>
            <a:ext cx="911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oth</a:t>
            </a:r>
          </a:p>
        </p:txBody>
      </p:sp>
    </p:spTree>
    <p:extLst>
      <p:ext uri="{BB962C8B-B14F-4D97-AF65-F5344CB8AC3E}">
        <p14:creationId xmlns:p14="http://schemas.microsoft.com/office/powerpoint/2010/main" val="12014298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2466" y="-52937"/>
            <a:ext cx="10515600" cy="1325563"/>
          </a:xfrm>
        </p:spPr>
        <p:txBody>
          <a:bodyPr/>
          <a:lstStyle/>
          <a:p>
            <a:r>
              <a:rPr lang="en-US" dirty="0"/>
              <a:t>Total RNAP II</a:t>
            </a:r>
          </a:p>
        </p:txBody>
      </p:sp>
      <p:pic>
        <p:nvPicPr>
          <p:cNvPr id="4" name="Picture 3"/>
          <p:cNvPicPr/>
          <p:nvPr/>
        </p:nvPicPr>
        <p:blipFill rotWithShape="1">
          <a:blip r:embed="rId2"/>
          <a:srcRect l="4342" r="14872" b="7194"/>
          <a:stretch/>
        </p:blipFill>
        <p:spPr>
          <a:xfrm>
            <a:off x="1382888" y="1083732"/>
            <a:ext cx="8274756" cy="523804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750453" y="1358065"/>
            <a:ext cx="82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359425" y="1350816"/>
            <a:ext cx="82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946444" y="1358065"/>
            <a:ext cx="82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134585" y="1366535"/>
            <a:ext cx="541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5991281" y="1358064"/>
            <a:ext cx="541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6525613" y="1364715"/>
            <a:ext cx="541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Trp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238086" y="1350816"/>
            <a:ext cx="9507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BET6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649510" y="1343567"/>
            <a:ext cx="642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BET6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47758" y="1350012"/>
            <a:ext cx="642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dBET6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3435959" y="1358064"/>
            <a:ext cx="642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oth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190506" y="1350011"/>
            <a:ext cx="642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oth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830452" y="1343567"/>
            <a:ext cx="642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/>
              <a:t>Both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333887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5356" y="-109009"/>
            <a:ext cx="10515600" cy="1325563"/>
          </a:xfrm>
        </p:spPr>
        <p:txBody>
          <a:bodyPr/>
          <a:lstStyle/>
          <a:p>
            <a:r>
              <a:rPr lang="en-US"/>
              <a:t>gH2AX</a:t>
            </a:r>
          </a:p>
        </p:txBody>
      </p:sp>
      <p:pic>
        <p:nvPicPr>
          <p:cNvPr id="4" name="Picture 3"/>
          <p:cNvPicPr/>
          <p:nvPr/>
        </p:nvPicPr>
        <p:blipFill rotWithShape="1">
          <a:blip r:embed="rId2"/>
          <a:srcRect r="14091"/>
          <a:stretch/>
        </p:blipFill>
        <p:spPr>
          <a:xfrm>
            <a:off x="1264567" y="969926"/>
            <a:ext cx="8172944" cy="5532473"/>
          </a:xfrm>
          <a:prstGeom prst="rect">
            <a:avLst/>
          </a:prstGeom>
        </p:spPr>
      </p:pic>
      <p:cxnSp>
        <p:nvCxnSpPr>
          <p:cNvPr id="6" name="Straight Connector 5"/>
          <p:cNvCxnSpPr/>
          <p:nvPr/>
        </p:nvCxnSpPr>
        <p:spPr>
          <a:xfrm>
            <a:off x="3962400" y="959556"/>
            <a:ext cx="45156" cy="55541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5757334" y="969926"/>
            <a:ext cx="4939" cy="553247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516990" y="969926"/>
            <a:ext cx="0" cy="553247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522238" y="1216554"/>
            <a:ext cx="1125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DMSO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08805" y="1226924"/>
            <a:ext cx="99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dBET6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319205" y="1226924"/>
            <a:ext cx="753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Trp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7961595" y="1226924"/>
            <a:ext cx="958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Both</a:t>
            </a:r>
          </a:p>
        </p:txBody>
      </p:sp>
    </p:spTree>
    <p:extLst>
      <p:ext uri="{BB962C8B-B14F-4D97-AF65-F5344CB8AC3E}">
        <p14:creationId xmlns:p14="http://schemas.microsoft.com/office/powerpoint/2010/main" val="7328321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2599972"/>
              </p:ext>
            </p:extLst>
          </p:nvPr>
        </p:nvGraphicFramePr>
        <p:xfrm>
          <a:off x="4966564" y="752475"/>
          <a:ext cx="3910735" cy="3219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6" name="Group 15"/>
          <p:cNvGrpSpPr/>
          <p:nvPr/>
        </p:nvGrpSpPr>
        <p:grpSpPr>
          <a:xfrm>
            <a:off x="981838" y="1646870"/>
            <a:ext cx="2657475" cy="180976"/>
            <a:chOff x="981837" y="1646871"/>
            <a:chExt cx="2657475" cy="18097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29537" y="1646872"/>
              <a:ext cx="666750" cy="180975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1837" y="1646872"/>
              <a:ext cx="647700" cy="180974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296287" y="1646872"/>
              <a:ext cx="647700" cy="180975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43987" y="1646871"/>
              <a:ext cx="695325" cy="180975"/>
            </a:xfrm>
            <a:prstGeom prst="rect">
              <a:avLst/>
            </a:prstGeom>
          </p:spPr>
        </p:pic>
      </p:grpSp>
      <p:sp>
        <p:nvSpPr>
          <p:cNvPr id="9" name="TextBox 8"/>
          <p:cNvSpPr txBox="1"/>
          <p:nvPr/>
        </p:nvSpPr>
        <p:spPr>
          <a:xfrm>
            <a:off x="3698892" y="153858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701939" y="1954505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RNAPII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981838" y="2001557"/>
            <a:ext cx="2657474" cy="249116"/>
            <a:chOff x="981838" y="2001557"/>
            <a:chExt cx="2657474" cy="249116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81838" y="2001557"/>
              <a:ext cx="647700" cy="249115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29538" y="2001558"/>
              <a:ext cx="666749" cy="249115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296287" y="2001558"/>
              <a:ext cx="647700" cy="249115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943987" y="2001559"/>
              <a:ext cx="695325" cy="249114"/>
            </a:xfrm>
            <a:prstGeom prst="rect">
              <a:avLst/>
            </a:prstGeom>
          </p:spPr>
        </p:pic>
      </p:grpSp>
      <p:pic>
        <p:nvPicPr>
          <p:cNvPr id="22" name="Picture 21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9137" y="1646870"/>
            <a:ext cx="2670279" cy="18289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963" y="2001559"/>
            <a:ext cx="2658086" cy="24995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2" name="TextBox 31"/>
          <p:cNvSpPr txBox="1"/>
          <p:nvPr/>
        </p:nvSpPr>
        <p:spPr>
          <a:xfrm>
            <a:off x="3713962" y="2356318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grpSp>
        <p:nvGrpSpPr>
          <p:cNvPr id="37" name="Group 36"/>
          <p:cNvGrpSpPr/>
          <p:nvPr/>
        </p:nvGrpSpPr>
        <p:grpSpPr>
          <a:xfrm>
            <a:off x="934213" y="2830453"/>
            <a:ext cx="2705099" cy="257529"/>
            <a:chOff x="934213" y="2830453"/>
            <a:chExt cx="2705099" cy="257529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34213" y="2830453"/>
              <a:ext cx="695326" cy="257528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14"/>
            <a:srcRect t="15409" b="14001"/>
            <a:stretch/>
          </p:blipFill>
          <p:spPr>
            <a:xfrm>
              <a:off x="1629539" y="2830453"/>
              <a:ext cx="652462" cy="257528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2267714" y="2830454"/>
              <a:ext cx="676274" cy="257528"/>
            </a:xfrm>
            <a:prstGeom prst="rect">
              <a:avLst/>
            </a:prstGeom>
          </p:spPr>
        </p:pic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2943988" y="2830454"/>
              <a:ext cx="695324" cy="257528"/>
            </a:xfrm>
            <a:prstGeom prst="rect">
              <a:avLst/>
            </a:prstGeom>
          </p:spPr>
        </p:pic>
      </p:grpSp>
      <p:pic>
        <p:nvPicPr>
          <p:cNvPr id="38" name="Picture 37"/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250" y="2825830"/>
            <a:ext cx="2670073" cy="26215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9" name="TextBox 38"/>
          <p:cNvSpPr txBox="1"/>
          <p:nvPr/>
        </p:nvSpPr>
        <p:spPr>
          <a:xfrm>
            <a:off x="3696552" y="2772239"/>
            <a:ext cx="932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-64781" y="675999"/>
            <a:ext cx="401488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MSO      +           -           -              -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RP           -           +           -             +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BET6       -           -           +             +</a:t>
            </a:r>
          </a:p>
        </p:txBody>
      </p:sp>
      <p:graphicFrame>
        <p:nvGraphicFramePr>
          <p:cNvPr id="47" name="Table 4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8515133"/>
              </p:ext>
            </p:extLst>
          </p:nvPr>
        </p:nvGraphicFramePr>
        <p:xfrm>
          <a:off x="1187610" y="4458494"/>
          <a:ext cx="2526352" cy="1574646"/>
        </p:xfrm>
        <a:graphic>
          <a:graphicData uri="http://schemas.openxmlformats.org/drawingml/2006/table">
            <a:tbl>
              <a:tblPr/>
              <a:tblGrid>
                <a:gridCol w="1777803">
                  <a:extLst>
                    <a:ext uri="{9D8B030D-6E8A-4147-A177-3AD203B41FA5}">
                      <a16:colId xmlns:a16="http://schemas.microsoft.com/office/drawing/2014/main" val="1808866513"/>
                    </a:ext>
                  </a:extLst>
                </a:gridCol>
                <a:gridCol w="748549">
                  <a:extLst>
                    <a:ext uri="{9D8B030D-6E8A-4147-A177-3AD203B41FA5}">
                      <a16:colId xmlns:a16="http://schemas.microsoft.com/office/drawing/2014/main" val="3457572864"/>
                    </a:ext>
                  </a:extLst>
                </a:gridCol>
              </a:tblGrid>
              <a:tr h="20481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NOVA summary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2205325"/>
                  </a:ext>
                </a:extLst>
              </a:tr>
              <a:tr h="20481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.87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6734780"/>
                  </a:ext>
                </a:extLst>
              </a:tr>
              <a:tr h="20481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 value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1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6955432"/>
                  </a:ext>
                </a:extLst>
              </a:tr>
              <a:tr h="20481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 value summary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***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847444"/>
                  </a:ext>
                </a:extLst>
              </a:tr>
              <a:tr h="39264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gnificant diff. among means (P &lt; 0.05)?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5555807"/>
                  </a:ext>
                </a:extLst>
              </a:tr>
              <a:tr h="20481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 square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083</a:t>
                      </a:r>
                    </a:p>
                  </a:txBody>
                  <a:tcPr marL="13521" marR="13521" marT="135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9423938"/>
                  </a:ext>
                </a:extLst>
              </a:tr>
            </a:tbl>
          </a:graphicData>
        </a:graphic>
      </p:graphicFrame>
      <p:graphicFrame>
        <p:nvGraphicFramePr>
          <p:cNvPr id="50" name="Table 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6419153"/>
              </p:ext>
            </p:extLst>
          </p:nvPr>
        </p:nvGraphicFramePr>
        <p:xfrm>
          <a:off x="4966565" y="4458494"/>
          <a:ext cx="5920510" cy="1951830"/>
        </p:xfrm>
        <a:graphic>
          <a:graphicData uri="http://schemas.openxmlformats.org/drawingml/2006/table">
            <a:tbl>
              <a:tblPr/>
              <a:tblGrid>
                <a:gridCol w="1408806">
                  <a:extLst>
                    <a:ext uri="{9D8B030D-6E8A-4147-A177-3AD203B41FA5}">
                      <a16:colId xmlns:a16="http://schemas.microsoft.com/office/drawing/2014/main" val="2221324164"/>
                    </a:ext>
                  </a:extLst>
                </a:gridCol>
                <a:gridCol w="929812">
                  <a:extLst>
                    <a:ext uri="{9D8B030D-6E8A-4147-A177-3AD203B41FA5}">
                      <a16:colId xmlns:a16="http://schemas.microsoft.com/office/drawing/2014/main" val="1287946699"/>
                    </a:ext>
                  </a:extLst>
                </a:gridCol>
                <a:gridCol w="1172832">
                  <a:extLst>
                    <a:ext uri="{9D8B030D-6E8A-4147-A177-3AD203B41FA5}">
                      <a16:colId xmlns:a16="http://schemas.microsoft.com/office/drawing/2014/main" val="1695851089"/>
                    </a:ext>
                  </a:extLst>
                </a:gridCol>
                <a:gridCol w="746668">
                  <a:extLst>
                    <a:ext uri="{9D8B030D-6E8A-4147-A177-3AD203B41FA5}">
                      <a16:colId xmlns:a16="http://schemas.microsoft.com/office/drawing/2014/main" val="3011367106"/>
                    </a:ext>
                  </a:extLst>
                </a:gridCol>
                <a:gridCol w="591699">
                  <a:extLst>
                    <a:ext uri="{9D8B030D-6E8A-4147-A177-3AD203B41FA5}">
                      <a16:colId xmlns:a16="http://schemas.microsoft.com/office/drawing/2014/main" val="1376424680"/>
                    </a:ext>
                  </a:extLst>
                </a:gridCol>
                <a:gridCol w="1070693">
                  <a:extLst>
                    <a:ext uri="{9D8B030D-6E8A-4147-A177-3AD203B41FA5}">
                      <a16:colId xmlns:a16="http://schemas.microsoft.com/office/drawing/2014/main" val="3354681842"/>
                    </a:ext>
                  </a:extLst>
                </a:gridCol>
              </a:tblGrid>
              <a:tr h="235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ukey's Ttes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an Diff.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5.00% CI of diff.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gnificant?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ummar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justed P 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8356679"/>
                  </a:ext>
                </a:extLst>
              </a:tr>
              <a:tr h="235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SO vs. TRP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05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2321 to 0.011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769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3285325"/>
                  </a:ext>
                </a:extLst>
              </a:tr>
              <a:tr h="38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SO vs. dBET6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35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5325 to -0.0182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3921712"/>
                  </a:ext>
                </a:extLst>
              </a:tr>
              <a:tr h="235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MSO vs. Both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00091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1759 to 0.017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&gt;0.999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0691861"/>
                  </a:ext>
                </a:extLst>
              </a:tr>
              <a:tr h="38801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P 4hr vs. dBET6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30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4754 to -0.012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*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1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890121"/>
                  </a:ext>
                </a:extLst>
              </a:tr>
              <a:tr h="235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P 4hr vs. Both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561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-0.01188 to 0.023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77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8913361"/>
                  </a:ext>
                </a:extLst>
              </a:tr>
              <a:tr h="23516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BET6 4hr vs. Both 4hr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356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1816 to 0.0531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***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00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70031972"/>
                  </a:ext>
                </a:extLst>
              </a:tr>
            </a:tbl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934212" y="2422463"/>
            <a:ext cx="2705712" cy="237043"/>
            <a:chOff x="934212" y="2422463"/>
            <a:chExt cx="2705712" cy="237043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934212" y="2422463"/>
              <a:ext cx="695326" cy="237043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629538" y="2422464"/>
              <a:ext cx="666749" cy="237042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2943987" y="2422464"/>
              <a:ext cx="695937" cy="235987"/>
            </a:xfrm>
            <a:prstGeom prst="rect">
              <a:avLst/>
            </a:prstGeom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1"/>
            <a:srcRect l="1243" r="1"/>
            <a:stretch/>
          </p:blipFill>
          <p:spPr>
            <a:xfrm>
              <a:off x="2293143" y="2422584"/>
              <a:ext cx="650843" cy="235867"/>
            </a:xfrm>
            <a:prstGeom prst="rect">
              <a:avLst/>
            </a:prstGeom>
          </p:spPr>
        </p:pic>
      </p:grpSp>
      <p:pic>
        <p:nvPicPr>
          <p:cNvPr id="10" name="Picture 9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451" y="2421574"/>
            <a:ext cx="2706859" cy="23776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30000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5</TotalTime>
  <Words>232</Words>
  <Application>Microsoft Macintosh PowerPoint</Application>
  <PresentationFormat>Widescreen</PresentationFormat>
  <Paragraphs>10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Triptolide-Mediated Rescue of dBET6</vt:lpstr>
      <vt:lpstr>Setup</vt:lpstr>
      <vt:lpstr>Brd4</vt:lpstr>
      <vt:lpstr>Total RNAP II</vt:lpstr>
      <vt:lpstr>gH2AX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iptolide-Mediated Rescue of dBET6</dc:title>
  <dc:creator>jling55799@gmail.com</dc:creator>
  <cp:lastModifiedBy>Drake Edwards</cp:lastModifiedBy>
  <cp:revision>18</cp:revision>
  <dcterms:created xsi:type="dcterms:W3CDTF">2017-11-20T20:16:28Z</dcterms:created>
  <dcterms:modified xsi:type="dcterms:W3CDTF">2019-11-24T22:06:34Z</dcterms:modified>
</cp:coreProperties>
</file>